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32" r:id="rId1"/>
  </p:sldMasterIdLst>
  <p:notesMasterIdLst>
    <p:notesMasterId r:id="rId4"/>
  </p:notesMasterIdLst>
  <p:sldIdLst>
    <p:sldId id="257" r:id="rId2"/>
    <p:sldId id="259" r:id="rId3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025" autoAdjust="0"/>
    <p:restoredTop sz="87984" autoAdjust="0"/>
  </p:normalViewPr>
  <p:slideViewPr>
    <p:cSldViewPr>
      <p:cViewPr varScale="1">
        <p:scale>
          <a:sx n="64" d="100"/>
          <a:sy n="64" d="100"/>
        </p:scale>
        <p:origin x="29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AT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54A436-AEAE-4239-B8C3-7A10B29C2923}" type="datetimeFigureOut">
              <a:rPr lang="de-AT" smtClean="0"/>
              <a:t>21.07.2023</a:t>
            </a:fld>
            <a:endParaRPr lang="de-AT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AT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3303F0F-4CD5-4E3E-A031-F75807B7072F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9579212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AT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3303F0F-4CD5-4E3E-A031-F75807B7072F}" type="slidenum">
              <a:rPr lang="de-AT" smtClean="0"/>
              <a:t>1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3265853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529E0-1D9B-47BF-8BAF-4C1C1651EB53}" type="datetimeFigureOut">
              <a:rPr lang="de-AT" smtClean="0"/>
              <a:t>21.07.2023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D3996-40ED-40F6-B378-08BA97BA88F9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5270760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529E0-1D9B-47BF-8BAF-4C1C1651EB53}" type="datetimeFigureOut">
              <a:rPr lang="de-AT" smtClean="0"/>
              <a:t>21.07.2023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D3996-40ED-40F6-B378-08BA97BA88F9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7322578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529E0-1D9B-47BF-8BAF-4C1C1651EB53}" type="datetimeFigureOut">
              <a:rPr lang="de-AT" smtClean="0"/>
              <a:t>21.07.2023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D3996-40ED-40F6-B378-08BA97BA88F9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2920729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529E0-1D9B-47BF-8BAF-4C1C1651EB53}" type="datetimeFigureOut">
              <a:rPr lang="de-AT" smtClean="0"/>
              <a:t>21.07.2023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D3996-40ED-40F6-B378-08BA97BA88F9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6447120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529E0-1D9B-47BF-8BAF-4C1C1651EB53}" type="datetimeFigureOut">
              <a:rPr lang="de-AT" smtClean="0"/>
              <a:t>21.07.2023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D3996-40ED-40F6-B378-08BA97BA88F9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9373609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529E0-1D9B-47BF-8BAF-4C1C1651EB53}" type="datetimeFigureOut">
              <a:rPr lang="de-AT" smtClean="0"/>
              <a:t>21.07.2023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D3996-40ED-40F6-B378-08BA97BA88F9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5044291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529E0-1D9B-47BF-8BAF-4C1C1651EB53}" type="datetimeFigureOut">
              <a:rPr lang="de-AT" smtClean="0"/>
              <a:t>21.07.2023</a:t>
            </a:fld>
            <a:endParaRPr lang="de-AT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D3996-40ED-40F6-B378-08BA97BA88F9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2676663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529E0-1D9B-47BF-8BAF-4C1C1651EB53}" type="datetimeFigureOut">
              <a:rPr lang="de-AT" smtClean="0"/>
              <a:t>21.07.2023</a:t>
            </a:fld>
            <a:endParaRPr lang="de-AT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D3996-40ED-40F6-B378-08BA97BA88F9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4722685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529E0-1D9B-47BF-8BAF-4C1C1651EB53}" type="datetimeFigureOut">
              <a:rPr lang="de-AT" smtClean="0"/>
              <a:t>21.07.2023</a:t>
            </a:fld>
            <a:endParaRPr lang="de-AT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D3996-40ED-40F6-B378-08BA97BA88F9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5761977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529E0-1D9B-47BF-8BAF-4C1C1651EB53}" type="datetimeFigureOut">
              <a:rPr lang="de-AT" smtClean="0"/>
              <a:t>21.07.2023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D3996-40ED-40F6-B378-08BA97BA88F9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8877531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de-AT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529E0-1D9B-47BF-8BAF-4C1C1651EB53}" type="datetimeFigureOut">
              <a:rPr lang="de-AT" smtClean="0"/>
              <a:t>21.07.2023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D3996-40ED-40F6-B378-08BA97BA88F9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4225742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0529E0-1D9B-47BF-8BAF-4C1C1651EB53}" type="datetimeFigureOut">
              <a:rPr lang="de-AT" smtClean="0"/>
              <a:t>21.07.2023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9D3996-40ED-40F6-B378-08BA97BA88F9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884434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11" Type="http://schemas.openxmlformats.org/officeDocument/2006/relationships/image" Target="../media/image9.jpg"/><Relationship Id="rId5" Type="http://schemas.openxmlformats.org/officeDocument/2006/relationships/image" Target="../media/image3.jpeg"/><Relationship Id="rId10" Type="http://schemas.openxmlformats.org/officeDocument/2006/relationships/image" Target="../media/image8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158C2216-AC64-2013-94CB-029E4A1ACD1F}"/>
              </a:ext>
            </a:extLst>
          </p:cNvPr>
          <p:cNvGrpSpPr/>
          <p:nvPr/>
        </p:nvGrpSpPr>
        <p:grpSpPr>
          <a:xfrm>
            <a:off x="1174583" y="-6567"/>
            <a:ext cx="9040298" cy="6820090"/>
            <a:chOff x="1174583" y="-6567"/>
            <a:chExt cx="9040298" cy="6820090"/>
          </a:xfrm>
        </p:grpSpPr>
        <p:pic>
          <p:nvPicPr>
            <p:cNvPr id="2" name="Grafik 1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770" t="5586" r="22962" b="4352"/>
            <a:stretch/>
          </p:blipFill>
          <p:spPr>
            <a:xfrm>
              <a:off x="1487489" y="369670"/>
              <a:ext cx="2202656" cy="2088232"/>
            </a:xfrm>
            <a:prstGeom prst="rect">
              <a:avLst/>
            </a:prstGeom>
          </p:spPr>
        </p:pic>
        <p:sp>
          <p:nvSpPr>
            <p:cNvPr id="3" name="Textfeld 2"/>
            <p:cNvSpPr txBox="1"/>
            <p:nvPr/>
          </p:nvSpPr>
          <p:spPr>
            <a:xfrm>
              <a:off x="1487489" y="-6567"/>
              <a:ext cx="13901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dirty="0"/>
                <a:t>Primary GC</a:t>
              </a:r>
            </a:p>
          </p:txBody>
        </p:sp>
        <p:sp>
          <p:nvSpPr>
            <p:cNvPr id="4" name="Textfeld 3"/>
            <p:cNvSpPr txBox="1"/>
            <p:nvPr/>
          </p:nvSpPr>
          <p:spPr>
            <a:xfrm>
              <a:off x="4655840" y="33189"/>
              <a:ext cx="261263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dirty="0"/>
                <a:t>Lymph node metastasis</a:t>
              </a:r>
            </a:p>
          </p:txBody>
        </p:sp>
        <p:sp>
          <p:nvSpPr>
            <p:cNvPr id="5" name="Textfeld 4"/>
            <p:cNvSpPr txBox="1"/>
            <p:nvPr/>
          </p:nvSpPr>
          <p:spPr>
            <a:xfrm>
              <a:off x="7874627" y="35660"/>
              <a:ext cx="20697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dirty="0"/>
                <a:t>Distant metastasis</a:t>
              </a:r>
            </a:p>
          </p:txBody>
        </p:sp>
        <p:pic>
          <p:nvPicPr>
            <p:cNvPr id="7" name="Grafik 6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311" t="4352" r="20770" b="1884"/>
            <a:stretch/>
          </p:blipFill>
          <p:spPr>
            <a:xfrm>
              <a:off x="4655840" y="369670"/>
              <a:ext cx="2253092" cy="2088232"/>
            </a:xfrm>
            <a:prstGeom prst="rect">
              <a:avLst/>
            </a:prstGeom>
          </p:spPr>
        </p:pic>
        <p:pic>
          <p:nvPicPr>
            <p:cNvPr id="8" name="Grafik 7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501" t="650" r="16386" b="1"/>
            <a:stretch/>
          </p:blipFill>
          <p:spPr>
            <a:xfrm>
              <a:off x="7874627" y="364362"/>
              <a:ext cx="2204215" cy="2088232"/>
            </a:xfrm>
            <a:prstGeom prst="rect">
              <a:avLst/>
            </a:prstGeom>
          </p:spPr>
        </p:pic>
        <p:sp>
          <p:nvSpPr>
            <p:cNvPr id="9" name="Textfeld 8"/>
            <p:cNvSpPr txBox="1"/>
            <p:nvPr/>
          </p:nvSpPr>
          <p:spPr>
            <a:xfrm>
              <a:off x="1174583" y="278369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dirty="0"/>
                <a:t>a</a:t>
              </a:r>
            </a:p>
          </p:txBody>
        </p:sp>
        <p:pic>
          <p:nvPicPr>
            <p:cNvPr id="10" name="Grafik 9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040" t="4352" r="20770" b="1884"/>
            <a:stretch/>
          </p:blipFill>
          <p:spPr>
            <a:xfrm>
              <a:off x="1474692" y="2452594"/>
              <a:ext cx="2228249" cy="2090703"/>
            </a:xfrm>
            <a:prstGeom prst="rect">
              <a:avLst/>
            </a:prstGeom>
          </p:spPr>
        </p:pic>
        <p:sp>
          <p:nvSpPr>
            <p:cNvPr id="11" name="Textfeld 10"/>
            <p:cNvSpPr txBox="1"/>
            <p:nvPr/>
          </p:nvSpPr>
          <p:spPr>
            <a:xfrm>
              <a:off x="1174583" y="2452594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dirty="0"/>
                <a:t>b</a:t>
              </a:r>
            </a:p>
          </p:txBody>
        </p:sp>
        <p:pic>
          <p:nvPicPr>
            <p:cNvPr id="12" name="Grafik 11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309" t="4352" r="22963" b="3118"/>
            <a:stretch/>
          </p:blipFill>
          <p:spPr>
            <a:xfrm>
              <a:off x="4648627" y="2452594"/>
              <a:ext cx="2280313" cy="2164854"/>
            </a:xfrm>
            <a:prstGeom prst="rect">
              <a:avLst/>
            </a:prstGeom>
          </p:spPr>
        </p:pic>
        <p:pic>
          <p:nvPicPr>
            <p:cNvPr id="13" name="Grafik 12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578" t="5586" r="21410"/>
            <a:stretch/>
          </p:blipFill>
          <p:spPr>
            <a:xfrm>
              <a:off x="7889052" y="2465829"/>
              <a:ext cx="2325829" cy="2167325"/>
            </a:xfrm>
            <a:prstGeom prst="rect">
              <a:avLst/>
            </a:prstGeom>
          </p:spPr>
        </p:pic>
        <p:pic>
          <p:nvPicPr>
            <p:cNvPr id="14" name="Grafik 13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232" t="3117" r="20040" b="1884"/>
            <a:stretch/>
          </p:blipFill>
          <p:spPr>
            <a:xfrm>
              <a:off x="1487489" y="4626819"/>
              <a:ext cx="2220168" cy="2163961"/>
            </a:xfrm>
            <a:prstGeom prst="rect">
              <a:avLst/>
            </a:prstGeom>
          </p:spPr>
        </p:pic>
        <p:sp>
          <p:nvSpPr>
            <p:cNvPr id="15" name="Textfeld 14"/>
            <p:cNvSpPr txBox="1"/>
            <p:nvPr/>
          </p:nvSpPr>
          <p:spPr>
            <a:xfrm>
              <a:off x="1174583" y="4707359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dirty="0"/>
                <a:t>c</a:t>
              </a:r>
            </a:p>
          </p:txBody>
        </p:sp>
        <p:pic>
          <p:nvPicPr>
            <p:cNvPr id="16" name="Grafik 15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501" t="8052" r="22963" b="1885"/>
            <a:stretch/>
          </p:blipFill>
          <p:spPr>
            <a:xfrm>
              <a:off x="4655350" y="4617448"/>
              <a:ext cx="2262648" cy="2173332"/>
            </a:xfrm>
            <a:prstGeom prst="rect">
              <a:avLst/>
            </a:prstGeom>
          </p:spPr>
        </p:pic>
        <p:pic>
          <p:nvPicPr>
            <p:cNvPr id="17" name="Grafik 16"/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693" t="9287" r="22232" b="5586"/>
            <a:stretch/>
          </p:blipFill>
          <p:spPr>
            <a:xfrm>
              <a:off x="7889052" y="4653210"/>
              <a:ext cx="2316858" cy="2160313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1655422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5BFB1461-7174-2C0F-89A3-2A86416CD857}"/>
              </a:ext>
            </a:extLst>
          </p:cNvPr>
          <p:cNvSpPr txBox="1"/>
          <p:nvPr/>
        </p:nvSpPr>
        <p:spPr>
          <a:xfrm>
            <a:off x="479376" y="332657"/>
            <a:ext cx="8663380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+mn-ea"/>
                <a:cs typeface="+mn-cs"/>
              </a:rPr>
              <a:t>Online Resource 5 PD-L1 expression in primary gastric adenocarcinoma (GC) and matched lymph node metastasis and distant metastasis from three patients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+mn-ea"/>
                <a:cs typeface="+mn-cs"/>
              </a:rPr>
              <a:t>a All three tumour sites with no PD-L1 expression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+mn-ea"/>
                <a:cs typeface="+mn-cs"/>
              </a:rPr>
              <a:t>b Only in the primary GC and lymph node metastasis with PD-L1 expression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+mn-ea"/>
                <a:cs typeface="+mn-cs"/>
              </a:rPr>
              <a:t>c All three tumour sites with PD-L1 expression</a:t>
            </a:r>
            <a:endParaRPr kumimoji="0" lang="de-AT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581313204"/>
      </p:ext>
    </p:extLst>
  </p:cSld>
  <p:clrMapOvr>
    <a:masterClrMapping/>
  </p:clrMapOvr>
</p:sld>
</file>

<file path=ppt/theme/theme1.xml><?xml version="1.0" encoding="utf-8"?>
<a:theme xmlns:a="http://schemas.openxmlformats.org/drawingml/2006/main" name="KUK1306">
  <a:themeElements>
    <a:clrScheme name="KUK_Farben">
      <a:dk1>
        <a:srgbClr val="000000"/>
      </a:dk1>
      <a:lt1>
        <a:srgbClr val="FFFFFF"/>
      </a:lt1>
      <a:dk2>
        <a:srgbClr val="575757"/>
      </a:dk2>
      <a:lt2>
        <a:srgbClr val="FFFFFF"/>
      </a:lt2>
      <a:accent1>
        <a:srgbClr val="E30613"/>
      </a:accent1>
      <a:accent2>
        <a:srgbClr val="9C1006"/>
      </a:accent2>
      <a:accent3>
        <a:srgbClr val="C6C6C6"/>
      </a:accent3>
      <a:accent4>
        <a:srgbClr val="F7CA34"/>
      </a:accent4>
      <a:accent5>
        <a:srgbClr val="E58E17"/>
      </a:accent5>
      <a:accent6>
        <a:srgbClr val="575757"/>
      </a:accent6>
      <a:hlink>
        <a:srgbClr val="E30613"/>
      </a:hlink>
      <a:folHlink>
        <a:srgbClr val="9C1006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BLANK.potm" id="{3D6CA131-89B8-427A-8BD8-DA1D2B45A7CC}" vid="{CE4098C0-1071-4352-A991-BC7A4CEE9FD6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18</TotalTime>
  <Words>64</Words>
  <Application>Microsoft Office PowerPoint</Application>
  <PresentationFormat>Widescreen</PresentationFormat>
  <Paragraphs>11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KUK1306</vt:lpstr>
      <vt:lpstr>PowerPoint Presentation</vt:lpstr>
      <vt:lpstr>PowerPoint Presentation</vt:lpstr>
    </vt:vector>
  </TitlesOfParts>
  <Company>Kepler Universitäts Kliniku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iu Drolaiz</dc:creator>
  <cp:lastModifiedBy>DHWLIU</cp:lastModifiedBy>
  <cp:revision>16</cp:revision>
  <dcterms:created xsi:type="dcterms:W3CDTF">2023-02-01T13:23:34Z</dcterms:created>
  <dcterms:modified xsi:type="dcterms:W3CDTF">2023-07-21T00:08:34Z</dcterms:modified>
</cp:coreProperties>
</file>